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53" r:id="rId2"/>
  </p:sldIdLst>
  <p:sldSz cx="6516688" cy="8999538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 userDrawn="1">
          <p15:clr>
            <a:srgbClr val="A4A3A4"/>
          </p15:clr>
        </p15:guide>
        <p15:guide id="2" pos="205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13"/>
    <p:restoredTop sz="85508" autoAdjust="0"/>
  </p:normalViewPr>
  <p:slideViewPr>
    <p:cSldViewPr>
      <p:cViewPr>
        <p:scale>
          <a:sx n="172" d="100"/>
          <a:sy n="172" d="100"/>
        </p:scale>
        <p:origin x="1624" y="-2336"/>
      </p:cViewPr>
      <p:guideLst>
        <p:guide orient="horz" pos="2835"/>
        <p:guide pos="205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C67782-E794-4E07-A31C-0B34991D395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87575" y="685800"/>
            <a:ext cx="24828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37B22C-4A1C-4B28-8A87-1DFE421198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7580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88752" y="2795690"/>
            <a:ext cx="5539185" cy="1929068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77503" y="5099738"/>
            <a:ext cx="4561682" cy="229988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258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516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775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033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292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9550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809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6067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724599" y="360400"/>
            <a:ext cx="1466255" cy="7678772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25834" y="360400"/>
            <a:ext cx="4290153" cy="7678772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773" y="5783037"/>
            <a:ext cx="5539185" cy="1787408"/>
          </a:xfrm>
        </p:spPr>
        <p:txBody>
          <a:bodyPr anchor="t"/>
          <a:lstStyle>
            <a:lvl1pPr algn="l">
              <a:defRPr sz="2851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14773" y="3814389"/>
            <a:ext cx="5539185" cy="1968648"/>
          </a:xfrm>
        </p:spPr>
        <p:txBody>
          <a:bodyPr anchor="b"/>
          <a:lstStyle>
            <a:lvl1pPr marL="0" indent="0">
              <a:buNone/>
              <a:defRPr sz="1425">
                <a:solidFill>
                  <a:schemeClr val="tx1">
                    <a:tint val="75000"/>
                  </a:schemeClr>
                </a:solidFill>
              </a:defRPr>
            </a:lvl1pPr>
            <a:lvl2pPr marL="325846" indent="0">
              <a:buNone/>
              <a:defRPr sz="1283">
                <a:solidFill>
                  <a:schemeClr val="tx1">
                    <a:tint val="75000"/>
                  </a:schemeClr>
                </a:solidFill>
              </a:defRPr>
            </a:lvl2pPr>
            <a:lvl3pPr marL="651693" indent="0">
              <a:buNone/>
              <a:defRPr sz="1140">
                <a:solidFill>
                  <a:schemeClr val="tx1">
                    <a:tint val="75000"/>
                  </a:schemeClr>
                </a:solidFill>
              </a:defRPr>
            </a:lvl3pPr>
            <a:lvl4pPr marL="977539" indent="0">
              <a:buNone/>
              <a:defRPr sz="998">
                <a:solidFill>
                  <a:schemeClr val="tx1">
                    <a:tint val="75000"/>
                  </a:schemeClr>
                </a:solidFill>
              </a:defRPr>
            </a:lvl4pPr>
            <a:lvl5pPr marL="1303386" indent="0">
              <a:buNone/>
              <a:defRPr sz="998">
                <a:solidFill>
                  <a:schemeClr val="tx1">
                    <a:tint val="75000"/>
                  </a:schemeClr>
                </a:solidFill>
              </a:defRPr>
            </a:lvl5pPr>
            <a:lvl6pPr marL="1629232" indent="0">
              <a:buNone/>
              <a:defRPr sz="998">
                <a:solidFill>
                  <a:schemeClr val="tx1">
                    <a:tint val="75000"/>
                  </a:schemeClr>
                </a:solidFill>
              </a:defRPr>
            </a:lvl6pPr>
            <a:lvl7pPr marL="1955079" indent="0">
              <a:buNone/>
              <a:defRPr sz="998">
                <a:solidFill>
                  <a:schemeClr val="tx1">
                    <a:tint val="75000"/>
                  </a:schemeClr>
                </a:solidFill>
              </a:defRPr>
            </a:lvl7pPr>
            <a:lvl8pPr marL="2280925" indent="0">
              <a:buNone/>
              <a:defRPr sz="998">
                <a:solidFill>
                  <a:schemeClr val="tx1">
                    <a:tint val="75000"/>
                  </a:schemeClr>
                </a:solidFill>
              </a:defRPr>
            </a:lvl8pPr>
            <a:lvl9pPr marL="2606772" indent="0">
              <a:buNone/>
              <a:defRPr sz="99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25834" y="2099893"/>
            <a:ext cx="2878204" cy="5939279"/>
          </a:xfrm>
        </p:spPr>
        <p:txBody>
          <a:bodyPr/>
          <a:lstStyle>
            <a:lvl1pPr>
              <a:defRPr sz="1996"/>
            </a:lvl1pPr>
            <a:lvl2pPr>
              <a:defRPr sz="1710"/>
            </a:lvl2pPr>
            <a:lvl3pPr>
              <a:defRPr sz="1425"/>
            </a:lvl3pPr>
            <a:lvl4pPr>
              <a:defRPr sz="1283"/>
            </a:lvl4pPr>
            <a:lvl5pPr>
              <a:defRPr sz="1283"/>
            </a:lvl5pPr>
            <a:lvl6pPr>
              <a:defRPr sz="1283"/>
            </a:lvl6pPr>
            <a:lvl7pPr>
              <a:defRPr sz="1283"/>
            </a:lvl7pPr>
            <a:lvl8pPr>
              <a:defRPr sz="1283"/>
            </a:lvl8pPr>
            <a:lvl9pPr>
              <a:defRPr sz="1283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312650" y="2099893"/>
            <a:ext cx="2878204" cy="5939279"/>
          </a:xfrm>
        </p:spPr>
        <p:txBody>
          <a:bodyPr/>
          <a:lstStyle>
            <a:lvl1pPr>
              <a:defRPr sz="1996"/>
            </a:lvl1pPr>
            <a:lvl2pPr>
              <a:defRPr sz="1710"/>
            </a:lvl2pPr>
            <a:lvl3pPr>
              <a:defRPr sz="1425"/>
            </a:lvl3pPr>
            <a:lvl4pPr>
              <a:defRPr sz="1283"/>
            </a:lvl4pPr>
            <a:lvl5pPr>
              <a:defRPr sz="1283"/>
            </a:lvl5pPr>
            <a:lvl6pPr>
              <a:defRPr sz="1283"/>
            </a:lvl6pPr>
            <a:lvl7pPr>
              <a:defRPr sz="1283"/>
            </a:lvl7pPr>
            <a:lvl8pPr>
              <a:defRPr sz="1283"/>
            </a:lvl8pPr>
            <a:lvl9pPr>
              <a:defRPr sz="1283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25834" y="2014480"/>
            <a:ext cx="2879336" cy="839540"/>
          </a:xfrm>
        </p:spPr>
        <p:txBody>
          <a:bodyPr anchor="b"/>
          <a:lstStyle>
            <a:lvl1pPr marL="0" indent="0">
              <a:buNone/>
              <a:defRPr sz="1710" b="1"/>
            </a:lvl1pPr>
            <a:lvl2pPr marL="325846" indent="0">
              <a:buNone/>
              <a:defRPr sz="1425" b="1"/>
            </a:lvl2pPr>
            <a:lvl3pPr marL="651693" indent="0">
              <a:buNone/>
              <a:defRPr sz="1283" b="1"/>
            </a:lvl3pPr>
            <a:lvl4pPr marL="977539" indent="0">
              <a:buNone/>
              <a:defRPr sz="1140" b="1"/>
            </a:lvl4pPr>
            <a:lvl5pPr marL="1303386" indent="0">
              <a:buNone/>
              <a:defRPr sz="1140" b="1"/>
            </a:lvl5pPr>
            <a:lvl6pPr marL="1629232" indent="0">
              <a:buNone/>
              <a:defRPr sz="1140" b="1"/>
            </a:lvl6pPr>
            <a:lvl7pPr marL="1955079" indent="0">
              <a:buNone/>
              <a:defRPr sz="1140" b="1"/>
            </a:lvl7pPr>
            <a:lvl8pPr marL="2280925" indent="0">
              <a:buNone/>
              <a:defRPr sz="1140" b="1"/>
            </a:lvl8pPr>
            <a:lvl9pPr marL="2606772" indent="0">
              <a:buNone/>
              <a:defRPr sz="114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25834" y="2854020"/>
            <a:ext cx="2879336" cy="5185151"/>
          </a:xfrm>
        </p:spPr>
        <p:txBody>
          <a:bodyPr/>
          <a:lstStyle>
            <a:lvl1pPr>
              <a:defRPr sz="1710"/>
            </a:lvl1pPr>
            <a:lvl2pPr>
              <a:defRPr sz="1425"/>
            </a:lvl2pPr>
            <a:lvl3pPr>
              <a:defRPr sz="1283"/>
            </a:lvl3pPr>
            <a:lvl4pPr>
              <a:defRPr sz="1140"/>
            </a:lvl4pPr>
            <a:lvl5pPr>
              <a:defRPr sz="1140"/>
            </a:lvl5pPr>
            <a:lvl6pPr>
              <a:defRPr sz="1140"/>
            </a:lvl6pPr>
            <a:lvl7pPr>
              <a:defRPr sz="1140"/>
            </a:lvl7pPr>
            <a:lvl8pPr>
              <a:defRPr sz="1140"/>
            </a:lvl8pPr>
            <a:lvl9pPr>
              <a:defRPr sz="114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310387" y="2014480"/>
            <a:ext cx="2880467" cy="839540"/>
          </a:xfrm>
        </p:spPr>
        <p:txBody>
          <a:bodyPr anchor="b"/>
          <a:lstStyle>
            <a:lvl1pPr marL="0" indent="0">
              <a:buNone/>
              <a:defRPr sz="1710" b="1"/>
            </a:lvl1pPr>
            <a:lvl2pPr marL="325846" indent="0">
              <a:buNone/>
              <a:defRPr sz="1425" b="1"/>
            </a:lvl2pPr>
            <a:lvl3pPr marL="651693" indent="0">
              <a:buNone/>
              <a:defRPr sz="1283" b="1"/>
            </a:lvl3pPr>
            <a:lvl4pPr marL="977539" indent="0">
              <a:buNone/>
              <a:defRPr sz="1140" b="1"/>
            </a:lvl4pPr>
            <a:lvl5pPr marL="1303386" indent="0">
              <a:buNone/>
              <a:defRPr sz="1140" b="1"/>
            </a:lvl5pPr>
            <a:lvl6pPr marL="1629232" indent="0">
              <a:buNone/>
              <a:defRPr sz="1140" b="1"/>
            </a:lvl6pPr>
            <a:lvl7pPr marL="1955079" indent="0">
              <a:buNone/>
              <a:defRPr sz="1140" b="1"/>
            </a:lvl7pPr>
            <a:lvl8pPr marL="2280925" indent="0">
              <a:buNone/>
              <a:defRPr sz="1140" b="1"/>
            </a:lvl8pPr>
            <a:lvl9pPr marL="2606772" indent="0">
              <a:buNone/>
              <a:defRPr sz="114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310387" y="2854020"/>
            <a:ext cx="2880467" cy="5185151"/>
          </a:xfrm>
        </p:spPr>
        <p:txBody>
          <a:bodyPr/>
          <a:lstStyle>
            <a:lvl1pPr>
              <a:defRPr sz="1710"/>
            </a:lvl1pPr>
            <a:lvl2pPr>
              <a:defRPr sz="1425"/>
            </a:lvl2pPr>
            <a:lvl3pPr>
              <a:defRPr sz="1283"/>
            </a:lvl3pPr>
            <a:lvl4pPr>
              <a:defRPr sz="1140"/>
            </a:lvl4pPr>
            <a:lvl5pPr>
              <a:defRPr sz="1140"/>
            </a:lvl5pPr>
            <a:lvl6pPr>
              <a:defRPr sz="1140"/>
            </a:lvl6pPr>
            <a:lvl7pPr>
              <a:defRPr sz="1140"/>
            </a:lvl7pPr>
            <a:lvl8pPr>
              <a:defRPr sz="1140"/>
            </a:lvl8pPr>
            <a:lvl9pPr>
              <a:defRPr sz="114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25835" y="358315"/>
            <a:ext cx="2143945" cy="1524922"/>
          </a:xfrm>
        </p:spPr>
        <p:txBody>
          <a:bodyPr anchor="b"/>
          <a:lstStyle>
            <a:lvl1pPr algn="l">
              <a:defRPr sz="1425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547844" y="358316"/>
            <a:ext cx="3643010" cy="7680856"/>
          </a:xfrm>
        </p:spPr>
        <p:txBody>
          <a:bodyPr/>
          <a:lstStyle>
            <a:lvl1pPr>
              <a:defRPr sz="2281"/>
            </a:lvl1pPr>
            <a:lvl2pPr>
              <a:defRPr sz="1996"/>
            </a:lvl2pPr>
            <a:lvl3pPr>
              <a:defRPr sz="1710"/>
            </a:lvl3pPr>
            <a:lvl4pPr>
              <a:defRPr sz="1425"/>
            </a:lvl4pPr>
            <a:lvl5pPr>
              <a:defRPr sz="1425"/>
            </a:lvl5pPr>
            <a:lvl6pPr>
              <a:defRPr sz="1425"/>
            </a:lvl6pPr>
            <a:lvl7pPr>
              <a:defRPr sz="1425"/>
            </a:lvl7pPr>
            <a:lvl8pPr>
              <a:defRPr sz="1425"/>
            </a:lvl8pPr>
            <a:lvl9pPr>
              <a:defRPr sz="1425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25835" y="1883237"/>
            <a:ext cx="2143945" cy="6155935"/>
          </a:xfrm>
        </p:spPr>
        <p:txBody>
          <a:bodyPr/>
          <a:lstStyle>
            <a:lvl1pPr marL="0" indent="0">
              <a:buNone/>
              <a:defRPr sz="998"/>
            </a:lvl1pPr>
            <a:lvl2pPr marL="325846" indent="0">
              <a:buNone/>
              <a:defRPr sz="855"/>
            </a:lvl2pPr>
            <a:lvl3pPr marL="651693" indent="0">
              <a:buNone/>
              <a:defRPr sz="713"/>
            </a:lvl3pPr>
            <a:lvl4pPr marL="977539" indent="0">
              <a:buNone/>
              <a:defRPr sz="641"/>
            </a:lvl4pPr>
            <a:lvl5pPr marL="1303386" indent="0">
              <a:buNone/>
              <a:defRPr sz="641"/>
            </a:lvl5pPr>
            <a:lvl6pPr marL="1629232" indent="0">
              <a:buNone/>
              <a:defRPr sz="641"/>
            </a:lvl6pPr>
            <a:lvl7pPr marL="1955079" indent="0">
              <a:buNone/>
              <a:defRPr sz="641"/>
            </a:lvl7pPr>
            <a:lvl8pPr marL="2280925" indent="0">
              <a:buNone/>
              <a:defRPr sz="641"/>
            </a:lvl8pPr>
            <a:lvl9pPr marL="2606772" indent="0">
              <a:buNone/>
              <a:defRPr sz="64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277316" y="6299677"/>
            <a:ext cx="3910013" cy="743712"/>
          </a:xfrm>
        </p:spPr>
        <p:txBody>
          <a:bodyPr anchor="b"/>
          <a:lstStyle>
            <a:lvl1pPr algn="l">
              <a:defRPr sz="1425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277316" y="804125"/>
            <a:ext cx="3910013" cy="5399723"/>
          </a:xfrm>
        </p:spPr>
        <p:txBody>
          <a:bodyPr/>
          <a:lstStyle>
            <a:lvl1pPr marL="0" indent="0">
              <a:buNone/>
              <a:defRPr sz="2281"/>
            </a:lvl1pPr>
            <a:lvl2pPr marL="325846" indent="0">
              <a:buNone/>
              <a:defRPr sz="1996"/>
            </a:lvl2pPr>
            <a:lvl3pPr marL="651693" indent="0">
              <a:buNone/>
              <a:defRPr sz="1710"/>
            </a:lvl3pPr>
            <a:lvl4pPr marL="977539" indent="0">
              <a:buNone/>
              <a:defRPr sz="1425"/>
            </a:lvl4pPr>
            <a:lvl5pPr marL="1303386" indent="0">
              <a:buNone/>
              <a:defRPr sz="1425"/>
            </a:lvl5pPr>
            <a:lvl6pPr marL="1629232" indent="0">
              <a:buNone/>
              <a:defRPr sz="1425"/>
            </a:lvl6pPr>
            <a:lvl7pPr marL="1955079" indent="0">
              <a:buNone/>
              <a:defRPr sz="1425"/>
            </a:lvl7pPr>
            <a:lvl8pPr marL="2280925" indent="0">
              <a:buNone/>
              <a:defRPr sz="1425"/>
            </a:lvl8pPr>
            <a:lvl9pPr marL="2606772" indent="0">
              <a:buNone/>
              <a:defRPr sz="14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277316" y="7043389"/>
            <a:ext cx="3910013" cy="1056195"/>
          </a:xfrm>
        </p:spPr>
        <p:txBody>
          <a:bodyPr/>
          <a:lstStyle>
            <a:lvl1pPr marL="0" indent="0">
              <a:buNone/>
              <a:defRPr sz="998"/>
            </a:lvl1pPr>
            <a:lvl2pPr marL="325846" indent="0">
              <a:buNone/>
              <a:defRPr sz="855"/>
            </a:lvl2pPr>
            <a:lvl3pPr marL="651693" indent="0">
              <a:buNone/>
              <a:defRPr sz="713"/>
            </a:lvl3pPr>
            <a:lvl4pPr marL="977539" indent="0">
              <a:buNone/>
              <a:defRPr sz="641"/>
            </a:lvl4pPr>
            <a:lvl5pPr marL="1303386" indent="0">
              <a:buNone/>
              <a:defRPr sz="641"/>
            </a:lvl5pPr>
            <a:lvl6pPr marL="1629232" indent="0">
              <a:buNone/>
              <a:defRPr sz="641"/>
            </a:lvl6pPr>
            <a:lvl7pPr marL="1955079" indent="0">
              <a:buNone/>
              <a:defRPr sz="641"/>
            </a:lvl7pPr>
            <a:lvl8pPr marL="2280925" indent="0">
              <a:buNone/>
              <a:defRPr sz="641"/>
            </a:lvl8pPr>
            <a:lvl9pPr marL="2606772" indent="0">
              <a:buNone/>
              <a:defRPr sz="64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25835" y="360399"/>
            <a:ext cx="5865019" cy="149992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25835" y="2099893"/>
            <a:ext cx="5865019" cy="59392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25834" y="8341239"/>
            <a:ext cx="1520561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226535" y="8341239"/>
            <a:ext cx="2063618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670293" y="8341239"/>
            <a:ext cx="1520561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51693" rtl="0" eaLnBrk="1" latinLnBrk="0" hangingPunct="1">
        <a:spcBef>
          <a:spcPct val="0"/>
        </a:spcBef>
        <a:buNone/>
        <a:defRPr kumimoji="1" sz="31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4385" indent="-244385" algn="l" defTabSz="651693" rtl="0" eaLnBrk="1" latinLnBrk="0" hangingPunct="1">
        <a:spcBef>
          <a:spcPct val="20000"/>
        </a:spcBef>
        <a:buFont typeface="Arial" pitchFamily="34" charset="0"/>
        <a:buChar char="•"/>
        <a:defRPr kumimoji="1" sz="2281" kern="1200">
          <a:solidFill>
            <a:schemeClr val="tx1"/>
          </a:solidFill>
          <a:latin typeface="+mn-lt"/>
          <a:ea typeface="+mn-ea"/>
          <a:cs typeface="+mn-cs"/>
        </a:defRPr>
      </a:lvl1pPr>
      <a:lvl2pPr marL="529500" indent="-203654" algn="l" defTabSz="651693" rtl="0" eaLnBrk="1" latinLnBrk="0" hangingPunct="1">
        <a:spcBef>
          <a:spcPct val="20000"/>
        </a:spcBef>
        <a:buFont typeface="Arial" pitchFamily="34" charset="0"/>
        <a:buChar char="–"/>
        <a:defRPr kumimoji="1" sz="1996" kern="1200">
          <a:solidFill>
            <a:schemeClr val="tx1"/>
          </a:solidFill>
          <a:latin typeface="+mn-lt"/>
          <a:ea typeface="+mn-ea"/>
          <a:cs typeface="+mn-cs"/>
        </a:defRPr>
      </a:lvl2pPr>
      <a:lvl3pPr marL="814616" indent="-162923" algn="l" defTabSz="651693" rtl="0" eaLnBrk="1" latinLnBrk="0" hangingPunct="1">
        <a:spcBef>
          <a:spcPct val="20000"/>
        </a:spcBef>
        <a:buFont typeface="Arial" pitchFamily="34" charset="0"/>
        <a:buChar char="•"/>
        <a:defRPr kumimoji="1" sz="1710" kern="1200">
          <a:solidFill>
            <a:schemeClr val="tx1"/>
          </a:solidFill>
          <a:latin typeface="+mn-lt"/>
          <a:ea typeface="+mn-ea"/>
          <a:cs typeface="+mn-cs"/>
        </a:defRPr>
      </a:lvl3pPr>
      <a:lvl4pPr marL="1140463" indent="-162923" algn="l" defTabSz="651693" rtl="0" eaLnBrk="1" latinLnBrk="0" hangingPunct="1">
        <a:spcBef>
          <a:spcPct val="20000"/>
        </a:spcBef>
        <a:buFont typeface="Arial" pitchFamily="34" charset="0"/>
        <a:buChar char="–"/>
        <a:defRPr kumimoji="1" sz="1425" kern="1200">
          <a:solidFill>
            <a:schemeClr val="tx1"/>
          </a:solidFill>
          <a:latin typeface="+mn-lt"/>
          <a:ea typeface="+mn-ea"/>
          <a:cs typeface="+mn-cs"/>
        </a:defRPr>
      </a:lvl4pPr>
      <a:lvl5pPr marL="1466309" indent="-162923" algn="l" defTabSz="651693" rtl="0" eaLnBrk="1" latinLnBrk="0" hangingPunct="1">
        <a:spcBef>
          <a:spcPct val="20000"/>
        </a:spcBef>
        <a:buFont typeface="Arial" pitchFamily="34" charset="0"/>
        <a:buChar char="»"/>
        <a:defRPr kumimoji="1" sz="1425" kern="1200">
          <a:solidFill>
            <a:schemeClr val="tx1"/>
          </a:solidFill>
          <a:latin typeface="+mn-lt"/>
          <a:ea typeface="+mn-ea"/>
          <a:cs typeface="+mn-cs"/>
        </a:defRPr>
      </a:lvl5pPr>
      <a:lvl6pPr marL="1792155" indent="-162923" algn="l" defTabSz="651693" rtl="0" eaLnBrk="1" latinLnBrk="0" hangingPunct="1">
        <a:spcBef>
          <a:spcPct val="20000"/>
        </a:spcBef>
        <a:buFont typeface="Arial" pitchFamily="34" charset="0"/>
        <a:buChar char="•"/>
        <a:defRPr kumimoji="1" sz="1425" kern="1200">
          <a:solidFill>
            <a:schemeClr val="tx1"/>
          </a:solidFill>
          <a:latin typeface="+mn-lt"/>
          <a:ea typeface="+mn-ea"/>
          <a:cs typeface="+mn-cs"/>
        </a:defRPr>
      </a:lvl6pPr>
      <a:lvl7pPr marL="2118002" indent="-162923" algn="l" defTabSz="651693" rtl="0" eaLnBrk="1" latinLnBrk="0" hangingPunct="1">
        <a:spcBef>
          <a:spcPct val="20000"/>
        </a:spcBef>
        <a:buFont typeface="Arial" pitchFamily="34" charset="0"/>
        <a:buChar char="•"/>
        <a:defRPr kumimoji="1" sz="1425" kern="1200">
          <a:solidFill>
            <a:schemeClr val="tx1"/>
          </a:solidFill>
          <a:latin typeface="+mn-lt"/>
          <a:ea typeface="+mn-ea"/>
          <a:cs typeface="+mn-cs"/>
        </a:defRPr>
      </a:lvl7pPr>
      <a:lvl8pPr marL="2443848" indent="-162923" algn="l" defTabSz="651693" rtl="0" eaLnBrk="1" latinLnBrk="0" hangingPunct="1">
        <a:spcBef>
          <a:spcPct val="20000"/>
        </a:spcBef>
        <a:buFont typeface="Arial" pitchFamily="34" charset="0"/>
        <a:buChar char="•"/>
        <a:defRPr kumimoji="1" sz="1425" kern="1200">
          <a:solidFill>
            <a:schemeClr val="tx1"/>
          </a:solidFill>
          <a:latin typeface="+mn-lt"/>
          <a:ea typeface="+mn-ea"/>
          <a:cs typeface="+mn-cs"/>
        </a:defRPr>
      </a:lvl8pPr>
      <a:lvl9pPr marL="2769695" indent="-162923" algn="l" defTabSz="651693" rtl="0" eaLnBrk="1" latinLnBrk="0" hangingPunct="1">
        <a:spcBef>
          <a:spcPct val="20000"/>
        </a:spcBef>
        <a:buFont typeface="Arial" pitchFamily="34" charset="0"/>
        <a:buChar char="•"/>
        <a:defRPr kumimoji="1" sz="14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51693" rtl="0" eaLnBrk="1" latinLnBrk="0" hangingPunct="1">
        <a:defRPr kumimoji="1" sz="1283" kern="1200">
          <a:solidFill>
            <a:schemeClr val="tx1"/>
          </a:solidFill>
          <a:latin typeface="+mn-lt"/>
          <a:ea typeface="+mn-ea"/>
          <a:cs typeface="+mn-cs"/>
        </a:defRPr>
      </a:lvl1pPr>
      <a:lvl2pPr marL="325846" algn="l" defTabSz="651693" rtl="0" eaLnBrk="1" latinLnBrk="0" hangingPunct="1">
        <a:defRPr kumimoji="1" sz="1283" kern="1200">
          <a:solidFill>
            <a:schemeClr val="tx1"/>
          </a:solidFill>
          <a:latin typeface="+mn-lt"/>
          <a:ea typeface="+mn-ea"/>
          <a:cs typeface="+mn-cs"/>
        </a:defRPr>
      </a:lvl2pPr>
      <a:lvl3pPr marL="651693" algn="l" defTabSz="651693" rtl="0" eaLnBrk="1" latinLnBrk="0" hangingPunct="1">
        <a:defRPr kumimoji="1" sz="1283" kern="1200">
          <a:solidFill>
            <a:schemeClr val="tx1"/>
          </a:solidFill>
          <a:latin typeface="+mn-lt"/>
          <a:ea typeface="+mn-ea"/>
          <a:cs typeface="+mn-cs"/>
        </a:defRPr>
      </a:lvl3pPr>
      <a:lvl4pPr marL="977539" algn="l" defTabSz="651693" rtl="0" eaLnBrk="1" latinLnBrk="0" hangingPunct="1">
        <a:defRPr kumimoji="1" sz="1283" kern="1200">
          <a:solidFill>
            <a:schemeClr val="tx1"/>
          </a:solidFill>
          <a:latin typeface="+mn-lt"/>
          <a:ea typeface="+mn-ea"/>
          <a:cs typeface="+mn-cs"/>
        </a:defRPr>
      </a:lvl4pPr>
      <a:lvl5pPr marL="1303386" algn="l" defTabSz="651693" rtl="0" eaLnBrk="1" latinLnBrk="0" hangingPunct="1">
        <a:defRPr kumimoji="1" sz="1283" kern="1200">
          <a:solidFill>
            <a:schemeClr val="tx1"/>
          </a:solidFill>
          <a:latin typeface="+mn-lt"/>
          <a:ea typeface="+mn-ea"/>
          <a:cs typeface="+mn-cs"/>
        </a:defRPr>
      </a:lvl5pPr>
      <a:lvl6pPr marL="1629232" algn="l" defTabSz="651693" rtl="0" eaLnBrk="1" latinLnBrk="0" hangingPunct="1">
        <a:defRPr kumimoji="1" sz="1283" kern="1200">
          <a:solidFill>
            <a:schemeClr val="tx1"/>
          </a:solidFill>
          <a:latin typeface="+mn-lt"/>
          <a:ea typeface="+mn-ea"/>
          <a:cs typeface="+mn-cs"/>
        </a:defRPr>
      </a:lvl6pPr>
      <a:lvl7pPr marL="1955079" algn="l" defTabSz="651693" rtl="0" eaLnBrk="1" latinLnBrk="0" hangingPunct="1">
        <a:defRPr kumimoji="1" sz="1283" kern="1200">
          <a:solidFill>
            <a:schemeClr val="tx1"/>
          </a:solidFill>
          <a:latin typeface="+mn-lt"/>
          <a:ea typeface="+mn-ea"/>
          <a:cs typeface="+mn-cs"/>
        </a:defRPr>
      </a:lvl7pPr>
      <a:lvl8pPr marL="2280925" algn="l" defTabSz="651693" rtl="0" eaLnBrk="1" latinLnBrk="0" hangingPunct="1">
        <a:defRPr kumimoji="1" sz="1283" kern="1200">
          <a:solidFill>
            <a:schemeClr val="tx1"/>
          </a:solidFill>
          <a:latin typeface="+mn-lt"/>
          <a:ea typeface="+mn-ea"/>
          <a:cs typeface="+mn-cs"/>
        </a:defRPr>
      </a:lvl8pPr>
      <a:lvl9pPr marL="2606772" algn="l" defTabSz="651693" rtl="0" eaLnBrk="1" latinLnBrk="0" hangingPunct="1">
        <a:defRPr kumimoji="1" sz="128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632779AC-2CB6-724A-8A66-5F973F8F5B6B}"/>
              </a:ext>
            </a:extLst>
          </p:cNvPr>
          <p:cNvSpPr/>
          <p:nvPr/>
        </p:nvSpPr>
        <p:spPr>
          <a:xfrm>
            <a:off x="306016" y="4355753"/>
            <a:ext cx="6192688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igure S1. There is no difference of ERV3-1 expression among three type of cytogenetic risk.</a:t>
            </a:r>
          </a:p>
          <a:p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mparison of ERV3-1 expression of all cases of the TCGA data. Statistical significance was assessed by Kruskal-Wallis test. The boxes denote the median, and the first and third quartile. The upper and lower whiskers represent the 90% and 10%, respectively. </a:t>
            </a:r>
            <a:endParaRPr lang="ja-JP" altLang="en-US" sz="100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2075E58B-9071-2141-ADD5-64565E6BDF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5705" y="1162769"/>
            <a:ext cx="3187467" cy="3187467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509E6BD-8B50-8D4D-A25C-FE99B6E929EF}"/>
              </a:ext>
            </a:extLst>
          </p:cNvPr>
          <p:cNvSpPr txBox="1"/>
          <p:nvPr/>
        </p:nvSpPr>
        <p:spPr>
          <a:xfrm>
            <a:off x="3980758" y="3707681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p = 0.077</a:t>
            </a:r>
            <a:endParaRPr kumimoji="1" lang="ja-JP" altLang="en-US" sz="120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7A08759-C823-BD43-AE89-733D51B4279B}"/>
              </a:ext>
            </a:extLst>
          </p:cNvPr>
          <p:cNvSpPr txBox="1"/>
          <p:nvPr/>
        </p:nvSpPr>
        <p:spPr>
          <a:xfrm>
            <a:off x="1458144" y="3966898"/>
            <a:ext cx="201622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EAD3DE3-D485-5948-81B2-438A2B9C32BE}"/>
              </a:ext>
            </a:extLst>
          </p:cNvPr>
          <p:cNvSpPr txBox="1"/>
          <p:nvPr/>
        </p:nvSpPr>
        <p:spPr>
          <a:xfrm>
            <a:off x="1303000" y="3908897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avorabl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3716228-DF3D-3F4A-96EB-20D4234D5D47}"/>
              </a:ext>
            </a:extLst>
          </p:cNvPr>
          <p:cNvSpPr txBox="1"/>
          <p:nvPr/>
        </p:nvSpPr>
        <p:spPr>
          <a:xfrm>
            <a:off x="2127171" y="3900583"/>
            <a:ext cx="893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ntermediat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AD0B11C-E225-AA44-8D18-CFF3FFB90DF8}"/>
              </a:ext>
            </a:extLst>
          </p:cNvPr>
          <p:cNvSpPr txBox="1"/>
          <p:nvPr/>
        </p:nvSpPr>
        <p:spPr>
          <a:xfrm>
            <a:off x="3092406" y="3893580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oor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1D1283FC-B753-D646-BAD6-636BFAB1299D}"/>
              </a:ext>
            </a:extLst>
          </p:cNvPr>
          <p:cNvSpPr/>
          <p:nvPr/>
        </p:nvSpPr>
        <p:spPr>
          <a:xfrm>
            <a:off x="450032" y="1619449"/>
            <a:ext cx="648072" cy="22741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E9979E2-004F-7943-B96F-0E0E31E6B71E}"/>
              </a:ext>
            </a:extLst>
          </p:cNvPr>
          <p:cNvSpPr txBox="1"/>
          <p:nvPr/>
        </p:nvSpPr>
        <p:spPr>
          <a:xfrm>
            <a:off x="882080" y="166126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2BA9D1B-5C09-8F4D-B2AE-C0E1822BE6EC}"/>
              </a:ext>
            </a:extLst>
          </p:cNvPr>
          <p:cNvSpPr txBox="1"/>
          <p:nvPr/>
        </p:nvSpPr>
        <p:spPr>
          <a:xfrm>
            <a:off x="882080" y="212763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016A237-BC44-3E42-B8D2-7AFEA62D9FA5}"/>
              </a:ext>
            </a:extLst>
          </p:cNvPr>
          <p:cNvSpPr txBox="1"/>
          <p:nvPr/>
        </p:nvSpPr>
        <p:spPr>
          <a:xfrm>
            <a:off x="882080" y="255555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7609082-839C-EA45-A33F-F96669267B99}"/>
              </a:ext>
            </a:extLst>
          </p:cNvPr>
          <p:cNvSpPr txBox="1"/>
          <p:nvPr/>
        </p:nvSpPr>
        <p:spPr>
          <a:xfrm>
            <a:off x="882080" y="301402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997FFDE-C89A-5448-AFFC-86C2CC7B4890}"/>
              </a:ext>
            </a:extLst>
          </p:cNvPr>
          <p:cNvSpPr txBox="1"/>
          <p:nvPr/>
        </p:nvSpPr>
        <p:spPr>
          <a:xfrm>
            <a:off x="882080" y="346146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1B64077-BF09-A94B-9288-011D274C5338}"/>
              </a:ext>
            </a:extLst>
          </p:cNvPr>
          <p:cNvSpPr txBox="1"/>
          <p:nvPr/>
        </p:nvSpPr>
        <p:spPr>
          <a:xfrm rot="16200000">
            <a:off x="1131" y="2004446"/>
            <a:ext cx="15760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RV3-1 expression (log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37838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20</TotalTime>
  <Words>80</Words>
  <Application>Microsoft Macintosh PowerPoint</Application>
  <PresentationFormat>ユーザー設定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</dc:creator>
  <cp:lastModifiedBy>中川　草</cp:lastModifiedBy>
  <cp:revision>555</cp:revision>
  <cp:lastPrinted>2019-04-27T07:26:56Z</cp:lastPrinted>
  <dcterms:created xsi:type="dcterms:W3CDTF">2017-08-26T11:50:39Z</dcterms:created>
  <dcterms:modified xsi:type="dcterms:W3CDTF">2020-09-08T13:31:21Z</dcterms:modified>
</cp:coreProperties>
</file>